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312C17-ACCA-4A0A-99B9-F900F8E6026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74DE4A-0E4D-4B84-A402-82AB1BDB9C8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A8C5B9-2F51-4AFD-B279-75177B7CD42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9B0760-DF22-4F34-98DB-114A3ABAEE8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E859C3-572A-454C-9783-79870B711F0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D72FA7-6C2F-4E21-A627-2D7DB20EA24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BD5295-DEE0-4D99-8E36-BCB4ED9709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D4E103-7123-4DEA-AAAF-7DEB45C927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111229-E4D1-479C-A17F-7A85DD26813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4C0B63-39D0-45A3-BAFC-10296E8F89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FE7941-E692-4157-867F-CBB814B4D1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766F13-A10C-41D0-8B47-E85093B2AF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EAE240E-E074-4725-8300-79AEA9C826A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838080" y="685800"/>
          <a:ext cx="4419720" cy="29718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838080" y="685800"/>
                    <a:ext cx="4419720" cy="2971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"/>
          <p:cNvSpPr/>
          <p:nvPr/>
        </p:nvSpPr>
        <p:spPr>
          <a:xfrm>
            <a:off x="4995360" y="1278000"/>
            <a:ext cx="1570680" cy="276480"/>
          </a:xfrm>
          <a:prstGeom prst="rect">
            <a:avLst/>
          </a:prstGeom>
          <a:noFill/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CD133+HI/CD44+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4427640" y="1422360"/>
            <a:ext cx="642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786120" y="1922400"/>
            <a:ext cx="12985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714760" y="2862360"/>
            <a:ext cx="2388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5000400" y="1785960"/>
            <a:ext cx="1265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CD133+/CD44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5020920" y="2724120"/>
            <a:ext cx="1750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CD133NEG/CD44NE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647640" y="457200"/>
            <a:ext cx="533520" cy="375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宋体"/>
              </a:rPr>
              <a:t>A                                              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0" name=""/>
          <p:cNvGrpSpPr/>
          <p:nvPr/>
        </p:nvGrpSpPr>
        <p:grpSpPr>
          <a:xfrm>
            <a:off x="676440" y="4048200"/>
            <a:ext cx="3698280" cy="2497320"/>
            <a:chOff x="676440" y="4048200"/>
            <a:chExt cx="3698280" cy="2497320"/>
          </a:xfrm>
        </p:grpSpPr>
        <p:sp>
          <p:nvSpPr>
            <p:cNvPr id="51" name=""/>
            <p:cNvSpPr/>
            <p:nvPr/>
          </p:nvSpPr>
          <p:spPr>
            <a:xfrm rot="20046600">
              <a:off x="2424960" y="6028920"/>
              <a:ext cx="1570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CD133NEG/CD44NE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 rot="20128200">
              <a:off x="1463760" y="5943600"/>
              <a:ext cx="1390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CD133+HI/CD44+H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 rot="20216400">
              <a:off x="749520" y="5876640"/>
              <a:ext cx="1085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CD133+/CD44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 rot="16200000">
              <a:off x="143280" y="4727520"/>
              <a:ext cx="1248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elative Quantit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5" name=""/>
            <p:cNvGrpSpPr/>
            <p:nvPr/>
          </p:nvGrpSpPr>
          <p:grpSpPr>
            <a:xfrm>
              <a:off x="959040" y="4048200"/>
              <a:ext cx="3415680" cy="1743120"/>
              <a:chOff x="959040" y="4048200"/>
              <a:chExt cx="3415680" cy="1743120"/>
            </a:xfrm>
          </p:grpSpPr>
          <p:sp>
            <p:nvSpPr>
              <p:cNvPr id="56" name=""/>
              <p:cNvSpPr/>
              <p:nvPr/>
            </p:nvSpPr>
            <p:spPr>
              <a:xfrm>
                <a:off x="1444320" y="5219640"/>
                <a:ext cx="531720" cy="442800"/>
              </a:xfrm>
              <a:prstGeom prst="rect">
                <a:avLst/>
              </a:prstGeom>
              <a:solidFill>
                <a:srgbClr val="ffffff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2508120" y="4395600"/>
                <a:ext cx="533160" cy="1266840"/>
              </a:xfrm>
              <a:prstGeom prst="rect">
                <a:avLst/>
              </a:prstGeom>
              <a:solidFill>
                <a:srgbClr val="ffffff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3573360" y="5097240"/>
                <a:ext cx="531360" cy="565200"/>
              </a:xfrm>
              <a:prstGeom prst="rect">
                <a:avLst/>
              </a:prstGeom>
              <a:solidFill>
                <a:srgbClr val="ffffff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 flipV="1">
                <a:off x="1706400" y="5118120"/>
                <a:ext cx="0" cy="1015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1682640" y="5118120"/>
                <a:ext cx="550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 flipV="1">
                <a:off x="2771640" y="4294080"/>
                <a:ext cx="0" cy="1015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2747880" y="4294080"/>
                <a:ext cx="550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 flipV="1">
                <a:off x="3835440" y="5015880"/>
                <a:ext cx="0" cy="810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200" bIns="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3811320" y="5016240"/>
                <a:ext cx="554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1182600" y="4103640"/>
                <a:ext cx="31320" cy="1558800"/>
              </a:xfrm>
              <a:custGeom>
                <a:avLst/>
                <a:gdLst/>
                <a:ahLst/>
                <a:rect l="l" t="t" r="r" b="b"/>
                <a:pathLst>
                  <a:path w="4" h="229">
                    <a:moveTo>
                      <a:pt x="0" y="0"/>
                    </a:moveTo>
                    <a:lnTo>
                      <a:pt x="0" y="229"/>
                    </a:lnTo>
                    <a:lnTo>
                      <a:pt x="4" y="229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1182600" y="5438520"/>
                <a:ext cx="31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1182600" y="5219640"/>
                <a:ext cx="31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1182600" y="4995720"/>
                <a:ext cx="31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1182600" y="4770360"/>
                <a:ext cx="31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1182600" y="4546440"/>
                <a:ext cx="31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1182600" y="4327560"/>
                <a:ext cx="31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1182600" y="4103640"/>
                <a:ext cx="31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1182600" y="5662440"/>
                <a:ext cx="31921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1046520" y="5608440"/>
                <a:ext cx="86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959040" y="5383080"/>
                <a:ext cx="2142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0.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1046520" y="5165640"/>
                <a:ext cx="86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959040" y="4940280"/>
                <a:ext cx="2142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1.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1046520" y="4716360"/>
                <a:ext cx="86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959040" y="4491000"/>
                <a:ext cx="2142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2.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1046520" y="4273560"/>
                <a:ext cx="86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959040" y="4048200"/>
                <a:ext cx="2142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3.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2731680" y="4089240"/>
                <a:ext cx="79920" cy="243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*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83" name=""/>
          <p:cNvGrpSpPr/>
          <p:nvPr/>
        </p:nvGrpSpPr>
        <p:grpSpPr>
          <a:xfrm>
            <a:off x="4977720" y="3708720"/>
            <a:ext cx="3530520" cy="2269800"/>
            <a:chOff x="4977720" y="3708720"/>
            <a:chExt cx="3530520" cy="2269800"/>
          </a:xfrm>
        </p:grpSpPr>
        <p:sp>
          <p:nvSpPr>
            <p:cNvPr id="84" name=""/>
            <p:cNvSpPr/>
            <p:nvPr/>
          </p:nvSpPr>
          <p:spPr>
            <a:xfrm rot="20196600">
              <a:off x="5642280" y="4068360"/>
              <a:ext cx="14457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CD133+/CD44+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 rot="20404200">
              <a:off x="6707520" y="4006440"/>
              <a:ext cx="1802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CD133+HI/CD44+HI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7418160" y="5624280"/>
              <a:ext cx="1040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r>
                <a:rPr b="1" lang="el-GR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α</a:t>
              </a: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Tubulin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7409160" y="5119560"/>
              <a:ext cx="732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-DHF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7408440" y="4620960"/>
              <a:ext cx="467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-T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4977720" y="4319640"/>
              <a:ext cx="506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kD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0" name=""/>
            <p:cNvGrpSpPr/>
            <p:nvPr/>
          </p:nvGrpSpPr>
          <p:grpSpPr>
            <a:xfrm>
              <a:off x="5024880" y="4592520"/>
              <a:ext cx="473040" cy="1318320"/>
              <a:chOff x="5024880" y="4592520"/>
              <a:chExt cx="473040" cy="1318320"/>
            </a:xfrm>
          </p:grpSpPr>
          <p:sp>
            <p:nvSpPr>
              <p:cNvPr id="91" name=""/>
              <p:cNvSpPr/>
              <p:nvPr/>
            </p:nvSpPr>
            <p:spPr>
              <a:xfrm>
                <a:off x="5024880" y="4592520"/>
                <a:ext cx="438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37-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5042160" y="5113080"/>
                <a:ext cx="438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21-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5059800" y="5603760"/>
                <a:ext cx="438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50-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aphicFrame>
          <p:nvGraphicFramePr>
            <p:cNvPr id="94" name=""/>
            <p:cNvGraphicFramePr/>
            <p:nvPr/>
          </p:nvGraphicFramePr>
          <p:xfrm>
            <a:off x="5476680" y="4562280"/>
            <a:ext cx="1955880" cy="38412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95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5476680" y="4562280"/>
                      <a:ext cx="1955880" cy="384120"/>
                    </a:xfrm>
                    <a:prstGeom prst="rect">
                      <a:avLst/>
                    </a:prstGeom>
                    <a:ln w="6480">
                      <a:solidFill>
                        <a:srgbClr val="000000"/>
                      </a:solidFill>
                      <a:miter/>
                    </a:ln>
                  </p:spPr>
                </p:pic>
              </p:oleObj>
            </a:graphicData>
          </a:graphic>
        </p:graphicFrame>
        <p:graphicFrame>
          <p:nvGraphicFramePr>
            <p:cNvPr id="96" name=""/>
            <p:cNvGraphicFramePr/>
            <p:nvPr/>
          </p:nvGraphicFramePr>
          <p:xfrm>
            <a:off x="5473440" y="5102280"/>
            <a:ext cx="1955880" cy="374400"/>
          </p:xfrm>
          <a:graphic>
            <a:graphicData uri="http://schemas.openxmlformats.org/presentationml/2006/ole">
              <p:oleObj r:id="rId5" spid="">
                <p:embed/>
                <p:pic>
                  <p:nvPicPr>
                    <p:cNvPr id="97" name="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5473440" y="5102280"/>
                      <a:ext cx="1955880" cy="374400"/>
                    </a:xfrm>
                    <a:prstGeom prst="rect">
                      <a:avLst/>
                    </a:prstGeom>
                    <a:ln w="6480">
                      <a:solidFill>
                        <a:srgbClr val="000000"/>
                      </a:solidFill>
                      <a:miter/>
                    </a:ln>
                  </p:spPr>
                </p:pic>
              </p:oleObj>
            </a:graphicData>
          </a:graphic>
        </p:graphicFrame>
        <p:graphicFrame>
          <p:nvGraphicFramePr>
            <p:cNvPr id="98" name=""/>
            <p:cNvGraphicFramePr/>
            <p:nvPr/>
          </p:nvGraphicFramePr>
          <p:xfrm>
            <a:off x="5473440" y="5613480"/>
            <a:ext cx="1955880" cy="365040"/>
          </p:xfrm>
          <a:graphic>
            <a:graphicData uri="http://schemas.openxmlformats.org/presentationml/2006/ole">
              <p:oleObj r:id="rId7" spid="">
                <p:embed/>
                <p:pic>
                  <p:nvPicPr>
                    <p:cNvPr id="99" name="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5473440" y="5613480"/>
                      <a:ext cx="1955880" cy="365040"/>
                    </a:xfrm>
                    <a:prstGeom prst="rect">
                      <a:avLst/>
                    </a:prstGeom>
                    <a:ln w="6480">
                      <a:solidFill>
                        <a:srgbClr val="000000"/>
                      </a:solidFill>
                      <a:miter/>
                    </a:ln>
                  </p:spPr>
                </p:pic>
              </p:oleObj>
            </a:graphicData>
          </a:graphic>
        </p:graphicFrame>
      </p:grpSp>
      <p:sp>
        <p:nvSpPr>
          <p:cNvPr id="100" name=""/>
          <p:cNvSpPr/>
          <p:nvPr/>
        </p:nvSpPr>
        <p:spPr>
          <a:xfrm>
            <a:off x="573120" y="3486240"/>
            <a:ext cx="47847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B                                                 C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4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02T16:18:47Z</dcterms:created>
  <dc:creator>sbo</dc:creator>
  <dc:description/>
  <dc:language>en-US</dc:language>
  <cp:lastModifiedBy>sbo</cp:lastModifiedBy>
  <dcterms:modified xsi:type="dcterms:W3CDTF">2010-04-09T18:44:37Z</dcterms:modified>
  <cp:revision>37</cp:revision>
  <dc:subject/>
  <dc:title>Slide 1</dc:title>
</cp:coreProperties>
</file>